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2" r:id="rId4"/>
    <p:sldId id="258" r:id="rId5"/>
    <p:sldId id="259" r:id="rId6"/>
    <p:sldId id="260" r:id="rId7"/>
    <p:sldId id="261" r:id="rId8"/>
    <p:sldId id="263" r:id="rId9"/>
    <p:sldId id="264" r:id="rId10"/>
    <p:sldId id="265" r:id="rId11"/>
    <p:sldId id="266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74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FD0CF9-7514-1409-886D-49899331DE4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CDDD10-F937-D183-2C74-1A1CBC20B8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EC43C5-81EE-4549-E5C7-49AE173F9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E79D5A-7F0F-5629-563D-A17880AF7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618F53-A141-153B-1C1A-6F43A79BD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546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26B975-4D8D-1E6C-2B97-0777B584D5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FA362F-4E99-7CF6-8BB7-4579B50270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5124F6-3D1F-A1FA-577D-5313922D9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C31DD0-2B20-F864-716D-2FCA78373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2FB179-8EAA-E0C7-95DA-C3181E2CE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757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4D4156E-BF35-7EB1-E187-FD9E819B0E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C199C7-B1FE-7DB4-0314-57CD2BC209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4DC48-D8BC-D389-959C-55AB9FE8F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C1B336-A462-0662-9D51-FBE3BCC0F5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A66224-ED6E-A5C5-5710-2B62B30CAD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262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9C137A-3D18-3436-26C6-BAAC03A2FD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A42DAB-25E6-36EE-15F0-CA367DABC9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9547EF-15FB-D42A-8516-C2904E240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4FF536-FE71-AD0C-E721-0CD87139C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E95646-FDE9-BD96-3268-0CFD10247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122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B21FBC-4555-A303-82F8-CB68CEC91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DE4BE2-D8F0-A9E4-E22D-B2BEEA011D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EA2170-0A1D-927F-4AC1-969E843CF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352D38-82E0-EF60-01CF-B596C77DA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056497-5972-319B-849A-C9D49773C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143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9A79C6-59D4-2E90-7BD5-3C22BDA7E6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25127B-2947-3133-40E9-6721FB8049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C68A3F-0B69-43B3-AB8B-2E59A255C0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0DFAC2-772C-7D00-3467-4CDA76E0F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70DA8C-0F7B-A8F9-07D4-1D2DC87C9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F6A9CF-10FD-85B4-AD6F-312F21CFB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835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BCA88B-1E91-468E-C00A-72F7D0B754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E3A963-92C5-A256-BC5B-B69F1884F6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8FE101-3818-C8BA-375C-B12FEB81E2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C60781-8058-9C46-04A7-36E7B8A1F1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11A057-76E9-915B-8F19-044B6F2FED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5BA2FB-A08A-6C00-8D39-07C7B4ADC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9D741CE-1709-2D26-C381-DB38B203A9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15E7B0-F9A0-6F06-76D9-4DFE459611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28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1D3FBB-989B-AD13-B3EA-01E090FF39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12895A-C383-1810-7093-6DDD47E89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35C1068-AA93-E047-0FC2-A2D55702F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33AA52C-5E5F-E696-59A7-DD3698D3B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206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2F6E7D-2EA3-1648-3036-3BA7F0D38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AE21D0-6317-681B-AE9F-A8166DF6E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9EC13E-8D0D-1358-8840-46ABFB0F3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083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34512-CF02-C936-EB44-FE25CC29FE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4FAB94-FBF1-CC66-81C2-49BE0B438D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43EF59-EADC-C7A9-1FE6-AF9C995AA3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D839A1-E503-96AB-A95D-95819A09C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1320EB-9B97-6EAB-8EFA-13DA8BF22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797FBB-2508-7774-C2C8-C82492813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565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F92084-FF27-7298-CBBB-3EE4944E41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D6785A-5FCD-3BC9-A914-335DBDF62B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EF1D69-D6FC-60C4-D7E5-380B3E753E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F6FBA6-4E58-1050-76C7-B7C76A890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366C61-2039-F42E-C68B-D025BDDD5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F3344A-BBA4-C2DB-188F-F81BC3021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136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E45DAE7-4DFF-5DEE-FBD5-C4FFF00E90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ED379C-8CFA-D7DB-B59C-55477A26AC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7BE100-8766-B401-A1F3-5255AF7AB4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9C1CAD-11F1-451F-A83F-CE7EBDF462F2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ED71F5-CEFA-9172-79C9-420416D0F3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ED1329-BAAD-5810-0C1C-B1B707CB11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4B7CF-14DE-4A57-A4FB-D97D3354D9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183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82EB8709-EFA0-C4D3-CA21-EEE9818F2A27}"/>
              </a:ext>
            </a:extLst>
          </p:cNvPr>
          <p:cNvSpPr txBox="1"/>
          <p:nvPr/>
        </p:nvSpPr>
        <p:spPr>
          <a:xfrm>
            <a:off x="3461716" y="4109748"/>
            <a:ext cx="5268567" cy="5956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3200" b="1" kern="100" dirty="0">
                <a:effectLst/>
                <a:latin typeface="Arial Black" panose="020B0A040201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s</a:t>
            </a:r>
            <a:endParaRPr lang="en-US" sz="3200" kern="100" dirty="0">
              <a:effectLst/>
              <a:latin typeface="Arial Black" panose="020B0A040201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352859D-ADB5-A9BC-2E87-FB0B5B440C23}"/>
              </a:ext>
            </a:extLst>
          </p:cNvPr>
          <p:cNvSpPr txBox="1"/>
          <p:nvPr/>
        </p:nvSpPr>
        <p:spPr>
          <a:xfrm>
            <a:off x="0" y="0"/>
            <a:ext cx="12192000" cy="27482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4000" kern="100" dirty="0">
                <a:latin typeface="Arial" panose="020B0604020202020204" pitchFamily="34" charset="0"/>
                <a:cs typeface="Arial" panose="020B0604020202020204" pitchFamily="34" charset="0"/>
              </a:rPr>
              <a:t>De-novo transcriptome analysis of </a:t>
            </a:r>
            <a:r>
              <a:rPr lang="en-US" sz="4000" kern="100" dirty="0" err="1">
                <a:latin typeface="Arial" panose="020B0604020202020204" pitchFamily="34" charset="0"/>
                <a:cs typeface="Arial" panose="020B0604020202020204" pitchFamily="34" charset="0"/>
              </a:rPr>
              <a:t>pyroxsulam</a:t>
            </a:r>
            <a:r>
              <a:rPr lang="en-US" sz="4000" kern="100" dirty="0">
                <a:latin typeface="Arial" panose="020B0604020202020204" pitchFamily="34" charset="0"/>
                <a:cs typeface="Arial" panose="020B0604020202020204" pitchFamily="34" charset="0"/>
              </a:rPr>
              <a:t>-resistant and susceptible </a:t>
            </a:r>
            <a:r>
              <a:rPr lang="en-US" sz="4000" i="1" kern="100" dirty="0">
                <a:latin typeface="Arial" panose="020B0604020202020204" pitchFamily="34" charset="0"/>
                <a:cs typeface="Arial" panose="020B0604020202020204" pitchFamily="34" charset="0"/>
              </a:rPr>
              <a:t>Bromus </a:t>
            </a:r>
            <a:r>
              <a:rPr lang="en-US" sz="4000" i="1" kern="100" dirty="0" err="1">
                <a:latin typeface="Arial" panose="020B0604020202020204" pitchFamily="34" charset="0"/>
                <a:cs typeface="Arial" panose="020B0604020202020204" pitchFamily="34" charset="0"/>
              </a:rPr>
              <a:t>sterilis</a:t>
            </a:r>
            <a:r>
              <a:rPr lang="en-US" sz="4000" i="1" kern="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4000" kern="100" dirty="0">
                <a:latin typeface="Arial" panose="020B0604020202020204" pitchFamily="34" charset="0"/>
                <a:cs typeface="Arial" panose="020B0604020202020204" pitchFamily="34" charset="0"/>
              </a:rPr>
              <a:t>identified three distinct mechanisms of resistance</a:t>
            </a:r>
          </a:p>
        </p:txBody>
      </p:sp>
    </p:spTree>
    <p:extLst>
      <p:ext uri="{BB962C8B-B14F-4D97-AF65-F5344CB8AC3E}">
        <p14:creationId xmlns:p14="http://schemas.microsoft.com/office/powerpoint/2010/main" val="214864756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F35F822-2886-7166-C191-54B9BE9ED38D}"/>
              </a:ext>
            </a:extLst>
          </p:cNvPr>
          <p:cNvSpPr txBox="1"/>
          <p:nvPr/>
        </p:nvSpPr>
        <p:spPr>
          <a:xfrm>
            <a:off x="1702903" y="6229127"/>
            <a:ext cx="8840155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9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GSEA-based bar plot for herbicide-treated R vs untreated R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picture containing text, screenshot, line, font&#10;&#10;Description automatically generated">
            <a:extLst>
              <a:ext uri="{FF2B5EF4-FFF2-40B4-BE49-F238E27FC236}">
                <a16:creationId xmlns:a16="http://schemas.microsoft.com/office/drawing/2014/main" id="{52BE512C-B176-B2D7-C350-5E11A5D4ED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28282"/>
            <a:ext cx="12192000" cy="4924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33366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0EAFC5E-99AE-9191-3A42-21BF7517F200}"/>
              </a:ext>
            </a:extLst>
          </p:cNvPr>
          <p:cNvSpPr txBox="1"/>
          <p:nvPr/>
        </p:nvSpPr>
        <p:spPr>
          <a:xfrm>
            <a:off x="1030540" y="6394471"/>
            <a:ext cx="9296217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800" b="1" kern="1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0</a:t>
            </a:r>
            <a:r>
              <a:rPr lang="en-US" sz="1800" kern="1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SEA-based bar plot for herbicide-treated S vs untreated S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picture containing text, screenshot, diagram, line&#10;&#10;Description automatically generated">
            <a:extLst>
              <a:ext uri="{FF2B5EF4-FFF2-40B4-BE49-F238E27FC236}">
                <a16:creationId xmlns:a16="http://schemas.microsoft.com/office/drawing/2014/main" id="{19F88274-6AE8-C5D2-0590-16D6DEFA92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66667"/>
            <a:ext cx="12192000" cy="4924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4146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, diagram, screenshot, line&#10;&#10;Description automatically generated">
            <a:extLst>
              <a:ext uri="{FF2B5EF4-FFF2-40B4-BE49-F238E27FC236}">
                <a16:creationId xmlns:a16="http://schemas.microsoft.com/office/drawing/2014/main" id="{EF985994-586D-FB45-1A20-4EB97A8962B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83" t="11325" r="12144" b="19444"/>
          <a:stretch/>
        </p:blipFill>
        <p:spPr bwMode="auto">
          <a:xfrm>
            <a:off x="86140" y="248478"/>
            <a:ext cx="7136297" cy="611682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60D9C8A-E3B1-8679-6C4A-73081CA4307F}"/>
              </a:ext>
            </a:extLst>
          </p:cNvPr>
          <p:cNvSpPr txBox="1"/>
          <p:nvPr/>
        </p:nvSpPr>
        <p:spPr>
          <a:xfrm>
            <a:off x="7222437" y="3306890"/>
            <a:ext cx="4899991" cy="24486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Principal Component Analysis (PCA) of RNA seq-based gene expression (GE) data from the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omus sterilis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amples. S and R represents the susceptible and resistant samples; C and BS represents control and herbicide treated. T represents treatment. Initially RNA extraction was done in 10 replicates (T1-T10). Among them, 5 best samples were chosen and sequenced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40120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2ADCB23-5878-0AD3-7235-1CAB3A4769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589" y="543577"/>
            <a:ext cx="4933109" cy="556938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3108B4A-C836-A1D1-16DC-0204690410F2}"/>
              </a:ext>
            </a:extLst>
          </p:cNvPr>
          <p:cNvSpPr txBox="1"/>
          <p:nvPr/>
        </p:nvSpPr>
        <p:spPr>
          <a:xfrm>
            <a:off x="6221897" y="4124739"/>
            <a:ext cx="4800600" cy="18558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The number of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ifferentially expressed genes for each experimental conditions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 and R represents the susceptible and resistant samples, respectively; C and T represents control and herbicide treated, respectively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52307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2243A08-7E4D-E00E-DBB0-15190C6D458E}"/>
              </a:ext>
            </a:extLst>
          </p:cNvPr>
          <p:cNvSpPr txBox="1"/>
          <p:nvPr/>
        </p:nvSpPr>
        <p:spPr>
          <a:xfrm>
            <a:off x="213645" y="6093557"/>
            <a:ext cx="11750467" cy="670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eatmap and volcano plot showing differential gene-level expression results for herbicide-treated R vs S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3C16A6A-5D49-9B23-E9F0-B862E2423E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561" y="94003"/>
            <a:ext cx="3389745" cy="591720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0ADBBB6-63C1-F3C6-B383-5668FBC366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64392" y="1270829"/>
            <a:ext cx="7584081" cy="431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63106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3EC2914-A98D-CE2E-C620-FE1ED9934123}"/>
              </a:ext>
            </a:extLst>
          </p:cNvPr>
          <p:cNvSpPr txBox="1"/>
          <p:nvPr/>
        </p:nvSpPr>
        <p:spPr>
          <a:xfrm>
            <a:off x="119642" y="6483923"/>
            <a:ext cx="11974728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4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eatmap and volcano plot showing differential gene-level expression results for untreated R vs S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B11E7AB-B63C-2875-EA1F-11721D0B4A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8674" y="1743342"/>
            <a:ext cx="7454005" cy="409646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EA7E92D-E314-1F19-4417-2FA2B7CFC9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9321" y="0"/>
            <a:ext cx="2432264" cy="6526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52054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C18FF95-1781-EB2E-9F8D-8AA517A9BB78}"/>
              </a:ext>
            </a:extLst>
          </p:cNvPr>
          <p:cNvSpPr txBox="1"/>
          <p:nvPr/>
        </p:nvSpPr>
        <p:spPr>
          <a:xfrm>
            <a:off x="0" y="6178724"/>
            <a:ext cx="12192000" cy="670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5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eatmap and volcano plot showing differential gene-level expression results for herbicide-treated R vs untreated R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832BF198-86AF-591F-7238-7098F51464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04424" y="1689893"/>
            <a:ext cx="6404265" cy="347821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9F80E9B-E37C-F671-1F51-AE3D9656FF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3838" y="83880"/>
            <a:ext cx="3080495" cy="60948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53531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FC503BA-501F-AD3C-3F0A-7C008DD711D6}"/>
              </a:ext>
            </a:extLst>
          </p:cNvPr>
          <p:cNvSpPr txBox="1"/>
          <p:nvPr/>
        </p:nvSpPr>
        <p:spPr>
          <a:xfrm>
            <a:off x="0" y="6187560"/>
            <a:ext cx="12085160" cy="670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6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Heatmap and volcano plot showing differential gene-level expression results for herbicide-treated S vs untreated S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E072D7C-4129-022E-E0FB-FFAE731F4A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3070" y="1129779"/>
            <a:ext cx="7704243" cy="459844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44C1196-4C59-805C-6350-A1D70E28D4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4110" y="120046"/>
            <a:ext cx="2038607" cy="60675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06574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4815EC9-451F-4CF2-0F47-D9BA423A225E}"/>
              </a:ext>
            </a:extLst>
          </p:cNvPr>
          <p:cNvSpPr txBox="1"/>
          <p:nvPr/>
        </p:nvSpPr>
        <p:spPr>
          <a:xfrm>
            <a:off x="2330864" y="6172402"/>
            <a:ext cx="7718989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7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GSEA-based bar plot for herbicide-treated R vs S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picture containing text, screenshot, line, diagram&#10;&#10;Description automatically generated">
            <a:extLst>
              <a:ext uri="{FF2B5EF4-FFF2-40B4-BE49-F238E27FC236}">
                <a16:creationId xmlns:a16="http://schemas.microsoft.com/office/drawing/2014/main" id="{F2018FAA-83EC-04C7-6652-4D837CE717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3919"/>
            <a:ext cx="12192000" cy="4924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30237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1597A0C-B3E9-925D-CD86-D1A9246E0A48}"/>
              </a:ext>
            </a:extLst>
          </p:cNvPr>
          <p:cNvSpPr txBox="1"/>
          <p:nvPr/>
        </p:nvSpPr>
        <p:spPr>
          <a:xfrm>
            <a:off x="1971262" y="6158957"/>
            <a:ext cx="8840155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8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GSEA-based bar plot for untreated R vs S.</a:t>
            </a:r>
            <a:endParaRPr lang="en-US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picture containing text, screenshot, line, number&#10;&#10;Description automatically generated">
            <a:extLst>
              <a:ext uri="{FF2B5EF4-FFF2-40B4-BE49-F238E27FC236}">
                <a16:creationId xmlns:a16="http://schemas.microsoft.com/office/drawing/2014/main" id="{8FA37916-4437-34B1-7669-A9123C9028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99198"/>
            <a:ext cx="12192000" cy="4924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0454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</TotalTime>
  <Words>257</Words>
  <Application>Microsoft Office PowerPoint</Application>
  <PresentationFormat>Widescreen</PresentationFormat>
  <Paragraphs>12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Arial Black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n</dc:creator>
  <cp:lastModifiedBy>Reviewer</cp:lastModifiedBy>
  <cp:revision>74</cp:revision>
  <dcterms:created xsi:type="dcterms:W3CDTF">2023-05-19T13:35:24Z</dcterms:created>
  <dcterms:modified xsi:type="dcterms:W3CDTF">2023-07-06T15:17:54Z</dcterms:modified>
</cp:coreProperties>
</file>